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683" autoAdjust="0"/>
  </p:normalViewPr>
  <p:slideViewPr>
    <p:cSldViewPr>
      <p:cViewPr varScale="1">
        <p:scale>
          <a:sx n="114" d="100"/>
          <a:sy n="114" d="100"/>
        </p:scale>
        <p:origin x="-102" y="-3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3973295894209306"/>
          <c:y val="7.3773542144870266E-2"/>
          <c:w val="0.84988958126922876"/>
          <c:h val="0.72174865403903576"/>
        </c:manualLayout>
      </c:layout>
      <c:lineChart>
        <c:grouping val="standard"/>
        <c:varyColors val="0"/>
        <c:ser>
          <c:idx val="0"/>
          <c:order val="0"/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dPt>
            <c:idx val="18"/>
            <c:bubble3D val="0"/>
          </c:dPt>
          <c:cat>
            <c:numRef>
              <c:f>'H:\Publikation - Masterarbeit\Resubmission\alt\[fig s3-.xlsx]1-Way CE Sensitivity Analysis'!$A$4:$A$34</c:f>
              <c:numCache>
                <c:formatCode>General</c:formatCode>
                <c:ptCount val="3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</c:numCache>
            </c:numRef>
          </c:cat>
          <c:val>
            <c:numRef>
              <c:f>'H:\Publikation - Masterarbeit\Resubmission\alt\[fig s3-.xlsx]1-Way CE Sensitivity Analysis'!$O$4:$O$34</c:f>
              <c:numCache>
                <c:formatCode>General</c:formatCode>
                <c:ptCount val="31"/>
                <c:pt idx="0">
                  <c:v>-1293.2475858659127</c:v>
                </c:pt>
                <c:pt idx="1">
                  <c:v>-1220.87961559838</c:v>
                </c:pt>
                <c:pt idx="2">
                  <c:v>-1148.5116453308474</c:v>
                </c:pt>
                <c:pt idx="3">
                  <c:v>-1076.1436750633147</c:v>
                </c:pt>
                <c:pt idx="4">
                  <c:v>-1003.7757047957821</c:v>
                </c:pt>
                <c:pt idx="5">
                  <c:v>-931.40773452824942</c:v>
                </c:pt>
                <c:pt idx="6">
                  <c:v>-859.03976426071677</c:v>
                </c:pt>
                <c:pt idx="7">
                  <c:v>-786.671793993184</c:v>
                </c:pt>
                <c:pt idx="8">
                  <c:v>-714.30382372565134</c:v>
                </c:pt>
                <c:pt idx="9">
                  <c:v>-641.93585345811891</c:v>
                </c:pt>
                <c:pt idx="10">
                  <c:v>-569.56788319058626</c:v>
                </c:pt>
                <c:pt idx="11">
                  <c:v>-497.19991292305338</c:v>
                </c:pt>
                <c:pt idx="12">
                  <c:v>-424.83194265552072</c:v>
                </c:pt>
                <c:pt idx="13">
                  <c:v>-352.46397238798806</c:v>
                </c:pt>
                <c:pt idx="14">
                  <c:v>-280.09600212045518</c:v>
                </c:pt>
                <c:pt idx="15">
                  <c:v>-207.72803185292273</c:v>
                </c:pt>
                <c:pt idx="16">
                  <c:v>-135.36006158539007</c:v>
                </c:pt>
                <c:pt idx="17">
                  <c:v>-62.992091317857195</c:v>
                </c:pt>
                <c:pt idx="18">
                  <c:v>9.3758789496752595</c:v>
                </c:pt>
                <c:pt idx="19">
                  <c:v>81.743849217207924</c:v>
                </c:pt>
                <c:pt idx="20">
                  <c:v>154.11181948474058</c:v>
                </c:pt>
                <c:pt idx="21">
                  <c:v>226.47978975227326</c:v>
                </c:pt>
                <c:pt idx="22">
                  <c:v>298.84776001980589</c:v>
                </c:pt>
                <c:pt idx="23">
                  <c:v>371.2157302873386</c:v>
                </c:pt>
                <c:pt idx="24">
                  <c:v>443.58370055487126</c:v>
                </c:pt>
                <c:pt idx="25">
                  <c:v>515.95167082240437</c:v>
                </c:pt>
                <c:pt idx="26">
                  <c:v>588.31964108993657</c:v>
                </c:pt>
                <c:pt idx="27">
                  <c:v>660.68761135746968</c:v>
                </c:pt>
                <c:pt idx="28">
                  <c:v>733.05558162500188</c:v>
                </c:pt>
                <c:pt idx="29">
                  <c:v>805.42355189253453</c:v>
                </c:pt>
                <c:pt idx="30">
                  <c:v>877.79152216006719</c:v>
                </c:pt>
              </c:numCache>
            </c:numRef>
          </c:val>
          <c:smooth val="0"/>
          <c:extLst xmlns:c16r2="http://schemas.microsoft.com/office/drawing/2015/06/chart"/>
        </c:ser>
        <c:ser>
          <c:idx val="1"/>
          <c:order val="1"/>
          <c:tx>
            <c:v>threshold</c:v>
          </c:tx>
          <c:marker>
            <c:symbol val="none"/>
          </c:marker>
          <c:val>
            <c:numRef>
              <c:f>'H:\Publikation - Masterarbeit\Resubmission\alt\[fig s3-.xlsx]1-Way CE Sensitivity Analysis'!$X$42</c:f>
              <c:numCache>
                <c:formatCode>General</c:formatCode>
                <c:ptCount val="1"/>
                <c:pt idx="0">
                  <c:v>178.70442</c:v>
                </c:pt>
              </c:numCache>
            </c:numRef>
          </c:val>
          <c:smooth val="0"/>
        </c:ser>
        <c:ser>
          <c:idx val="2"/>
          <c:order val="2"/>
          <c:marker>
            <c:symbol val="none"/>
          </c:marker>
          <c:val>
            <c:numRef>
              <c:f>'H:\Publikation - Masterarbeit\Resubmission\alt\[fig s3-.xlsx]1-Way CE Sensitivity Analysis'!$X$42</c:f>
              <c:numCache>
                <c:formatCode>General</c:formatCode>
                <c:ptCount val="1"/>
                <c:pt idx="0">
                  <c:v>178.7044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4209152"/>
        <c:axId val="94210688"/>
      </c:lineChart>
      <c:catAx>
        <c:axId val="94209152"/>
        <c:scaling>
          <c:orientation val="minMax"/>
        </c:scaling>
        <c:delete val="0"/>
        <c:axPos val="b"/>
        <c:numFmt formatCode="#,##0" sourceLinked="0"/>
        <c:majorTickMark val="cross"/>
        <c:minorTickMark val="in"/>
        <c:tickLblPos val="low"/>
        <c:spPr>
          <a:ln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94210688"/>
        <c:crossesAt val="0"/>
        <c:auto val="1"/>
        <c:lblAlgn val="ctr"/>
        <c:lblOffset val="100"/>
        <c:tickLblSkip val="2"/>
        <c:noMultiLvlLbl val="0"/>
      </c:catAx>
      <c:valAx>
        <c:axId val="94210688"/>
        <c:scaling>
          <c:orientation val="minMax"/>
          <c:max val="900"/>
          <c:min val="-1300"/>
        </c:scaling>
        <c:delete val="0"/>
        <c:axPos val="l"/>
        <c:numFmt formatCode="0" sourceLinked="0"/>
        <c:majorTickMark val="out"/>
        <c:minorTickMark val="none"/>
        <c:tickLblPos val="low"/>
        <c:spPr>
          <a:ln>
            <a:solidFill>
              <a:srgbClr val="808080"/>
            </a:solidFill>
            <a:prstDash val="solid"/>
          </a:ln>
        </c:spPr>
        <c:crossAx val="94209152"/>
        <c:crossesAt val="1"/>
        <c:crossBetween val="midCat"/>
        <c:majorUnit val="200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1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4652</cdr:x>
      <cdr:y>0.2668</cdr:y>
    </cdr:from>
    <cdr:to>
      <cdr:x>0.67272</cdr:x>
      <cdr:y>0.33588</cdr:y>
    </cdr:to>
    <cdr:sp macro="" textlink="">
      <cdr:nvSpPr>
        <cdr:cNvPr id="2" name="Rechteck 1"/>
        <cdr:cNvSpPr/>
      </cdr:nvSpPr>
      <cdr:spPr>
        <a:xfrm xmlns:a="http://schemas.openxmlformats.org/drawingml/2006/main">
          <a:off x="2538024" y="988605"/>
          <a:ext cx="586073" cy="25597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25400" cap="flat" cmpd="sng" algn="ctr">
          <a:noFill/>
          <a:prstDash val="solid"/>
        </a:ln>
        <a:effectLst xmlns:a="http://schemas.openxmlformats.org/drawingml/2006/main"/>
      </cdr:spPr>
      <cdr:txBody>
        <a:bodyPr xmlns:a="http://schemas.openxmlformats.org/drawingml/2006/main" rot="0" spcFirstLastPara="0" vert="horz" wrap="square" lIns="91440" tIns="45720" rIns="91440" bIns="45720" numCol="1" spcCol="0" rtlCol="0" fromWordArt="0" anchor="ctr" anchorCtr="0" forceAA="0" compatLnSpc="1">
          <a:prstTxWarp prst="textNoShape">
            <a:avLst/>
          </a:prstTxWarp>
          <a:noAutofit/>
        </a:bodyPr>
        <a:lstStyle xmlns:a="http://schemas.openxmlformats.org/drawingml/2006/main"/>
        <a:p xmlns:a="http://schemas.openxmlformats.org/drawingml/2006/main">
          <a:pPr algn="ctr">
            <a:lnSpc>
              <a:spcPct val="150000"/>
            </a:lnSpc>
            <a:spcAft>
              <a:spcPts val="800"/>
            </a:spcAft>
          </a:pPr>
          <a:r>
            <a:rPr lang="en-GB" sz="1100" dirty="0">
              <a:effectLst/>
              <a:latin typeface="Times New Roman"/>
              <a:ea typeface="Times New Roman"/>
            </a:rPr>
            <a:t>€179</a:t>
          </a:r>
        </a:p>
      </cdr:txBody>
    </cdr:sp>
  </cdr:relSizeAnchor>
  <cdr:relSizeAnchor xmlns:cdr="http://schemas.openxmlformats.org/drawingml/2006/chartDrawing">
    <cdr:from>
      <cdr:x>0.0098</cdr:x>
      <cdr:y>0.86472</cdr:y>
    </cdr:from>
    <cdr:to>
      <cdr:x>0.98067</cdr:x>
      <cdr:y>0.93051</cdr:y>
    </cdr:to>
    <cdr:sp macro="" textlink="">
      <cdr:nvSpPr>
        <cdr:cNvPr id="4" name="Rechteck 3"/>
        <cdr:cNvSpPr/>
      </cdr:nvSpPr>
      <cdr:spPr bwMode="auto">
        <a:xfrm xmlns:a="http://schemas.openxmlformats.org/drawingml/2006/main" rot="5400000">
          <a:off x="1910685" y="940127"/>
          <a:ext cx="213856" cy="395540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="vert270" rtlCol="0" anchor="ctr" anchorCtr="1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l"/>
          <a:r>
            <a:rPr lang="en-GB" sz="1100" b="1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Intervention costs of UG per </a:t>
          </a:r>
          <a:r>
            <a:rPr lang="en-GB" sz="1100" b="1" dirty="0" smtClean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procedure in </a:t>
          </a:r>
          <a:r>
            <a:rPr lang="en-GB" sz="1100" b="1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€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612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3019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519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8676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2981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6406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6019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914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325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4685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125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DC7CB-84AF-4017-A5BF-E5FD551C96CB}" type="datetimeFigureOut">
              <a:rPr lang="en-GB" smtClean="0"/>
              <a:t>25/01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B24EA-BB61-4C7C-87DB-2AE83DA1FB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0233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>
            <a:grpSpLocks noChangeAspect="1"/>
          </p:cNvGrpSpPr>
          <p:nvPr/>
        </p:nvGrpSpPr>
        <p:grpSpPr>
          <a:xfrm>
            <a:off x="2051720" y="1239148"/>
            <a:ext cx="4284000" cy="3612504"/>
            <a:chOff x="2051720" y="1239143"/>
            <a:chExt cx="4842280" cy="4083274"/>
          </a:xfrm>
        </p:grpSpPr>
        <p:graphicFrame>
          <p:nvGraphicFramePr>
            <p:cNvPr id="2" name="Diagramm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12870887"/>
                </p:ext>
              </p:extLst>
            </p:nvPr>
          </p:nvGraphicFramePr>
          <p:xfrm>
            <a:off x="2250000" y="1576299"/>
            <a:ext cx="4644000" cy="37054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Textfeld 2"/>
            <p:cNvSpPr txBox="1"/>
            <p:nvPr/>
          </p:nvSpPr>
          <p:spPr>
            <a:xfrm>
              <a:off x="2123728" y="1239143"/>
              <a:ext cx="4680520" cy="4911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spcBef>
                  <a:spcPts val="600"/>
                </a:spcBef>
                <a:spcAft>
                  <a:spcPts val="1200"/>
                </a:spcAft>
              </a:pPr>
              <a:r>
                <a:rPr lang="en-GB" sz="1100" b="1" kern="0" dirty="0" smtClean="0">
                  <a:effectLst/>
                  <a:latin typeface="Times New Roman"/>
                  <a:ea typeface="Calibri"/>
                </a:rPr>
                <a:t>Additional file </a:t>
              </a:r>
              <a:r>
                <a:rPr lang="en-GB" sz="1100" b="1" kern="0" dirty="0">
                  <a:latin typeface="Times New Roman"/>
                  <a:ea typeface="Calibri"/>
                </a:rPr>
                <a:t>6</a:t>
              </a:r>
              <a:r>
                <a:rPr lang="en-GB" sz="1100" b="1" kern="0" dirty="0" smtClean="0">
                  <a:effectLst/>
                  <a:latin typeface="Times New Roman"/>
                  <a:ea typeface="Calibri"/>
                </a:rPr>
                <a:t>: </a:t>
              </a:r>
              <a:r>
                <a:rPr lang="en-GB" sz="1100" kern="0" dirty="0">
                  <a:latin typeface="Times New Roman"/>
                  <a:ea typeface="Times New Roman"/>
                </a:rPr>
                <a:t>Results of the threshold analysis for intervention costs of ultrasound guidance</a:t>
              </a:r>
              <a:endParaRPr lang="en-GB" sz="1100" b="1" kern="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2123728" y="5024209"/>
              <a:ext cx="4680520" cy="298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CER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cremental cost-effectiveness ratio, </a:t>
              </a:r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G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ultrasound guidance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hteck 4"/>
            <p:cNvSpPr/>
            <p:nvPr/>
          </p:nvSpPr>
          <p:spPr bwMode="auto">
            <a:xfrm>
              <a:off x="2051720" y="1764779"/>
              <a:ext cx="243774" cy="260032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 anchorCtr="1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GB" sz="11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CER per </a:t>
              </a:r>
              <a:r>
                <a:rPr lang="en-GB" sz="1100" b="1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voided </a:t>
              </a:r>
              <a:r>
                <a:rPr lang="en-GB" sz="11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plication in €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1239050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K-Koel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Yana Seleznova</dc:creator>
  <cp:lastModifiedBy>Yana Seleznova</cp:lastModifiedBy>
  <cp:revision>6</cp:revision>
  <dcterms:created xsi:type="dcterms:W3CDTF">2018-10-08T09:01:03Z</dcterms:created>
  <dcterms:modified xsi:type="dcterms:W3CDTF">2019-01-25T08:48:28Z</dcterms:modified>
</cp:coreProperties>
</file>